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792913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450A78-B9E1-4492-A9E9-24735C4BF7E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2F9BEC-26AE-4FAE-92FA-C1F27DE510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89E82-4F75-4160-9BEC-FE9EED2FC12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C9795-9BB7-4D54-8673-5C5C71F9E1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62122C-EDBD-4C1A-BC74-B20921E40E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C6100-13C9-4F21-87D7-E4CDFB9778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7DA55D-C0AB-4759-ACE6-4EA5607DD2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E5105-F5DE-4670-94FD-BB181FE313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225053-FCE1-469C-A0DF-64AAB79D1C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AC880A-861A-45C6-9059-07078354D1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BFFD7-952A-4462-8AEC-EF622003B7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DAB38-51F2-40C3-90A5-0EE3D7CD636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81A07B-44AB-40C5-B91E-9B2520AAAE0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image" Target="../media/image1.wmf"/><Relationship Id="rId4" Type="http://schemas.openxmlformats.org/officeDocument/2006/relationships/image" Target="../media/image1.wmf"/><Relationship Id="rId5" Type="http://schemas.openxmlformats.org/officeDocument/2006/relationships/image" Target="../media/image2.wmf"/><Relationship Id="rId6" Type="http://schemas.openxmlformats.org/officeDocument/2006/relationships/image" Target="../media/image2.wmf"/><Relationship Id="rId7" Type="http://schemas.openxmlformats.org/officeDocument/2006/relationships/image" Target="../media/image2.wmf"/><Relationship Id="rId8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wmf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276720" y="6308640"/>
            <a:ext cx="352728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Variant frequencie (%) per sample (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Fij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6308640"/>
            <a:ext cx="1476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324000" y="233280"/>
            <a:ext cx="8718480" cy="6132600"/>
            <a:chOff x="324000" y="233280"/>
            <a:chExt cx="8718480" cy="6132600"/>
          </a:xfrm>
        </p:grpSpPr>
        <p:grpSp>
          <p:nvGrpSpPr>
            <p:cNvPr id="44" name=""/>
            <p:cNvGrpSpPr/>
            <p:nvPr/>
          </p:nvGrpSpPr>
          <p:grpSpPr>
            <a:xfrm>
              <a:off x="324000" y="233280"/>
              <a:ext cx="8624880" cy="6132600"/>
              <a:chOff x="324000" y="233280"/>
              <a:chExt cx="8624880" cy="6132600"/>
            </a:xfrm>
          </p:grpSpPr>
          <p:grpSp>
            <p:nvGrpSpPr>
              <p:cNvPr id="45" name=""/>
              <p:cNvGrpSpPr/>
              <p:nvPr/>
            </p:nvGrpSpPr>
            <p:grpSpPr>
              <a:xfrm>
                <a:off x="684360" y="233280"/>
                <a:ext cx="8264520" cy="6132600"/>
                <a:chOff x="684360" y="233280"/>
                <a:chExt cx="8264520" cy="6132600"/>
              </a:xfrm>
            </p:grpSpPr>
            <p:pic>
              <p:nvPicPr>
                <p:cNvPr id="46" name="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684360" y="233280"/>
                  <a:ext cx="8264520" cy="60343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" descr=""/>
                <p:cNvPicPr/>
                <p:nvPr/>
              </p:nvPicPr>
              <p:blipFill>
                <a:blip r:embed="rId2"/>
                <a:srcRect l="70570" t="73674" r="0" b="22953"/>
                <a:stretch/>
              </p:blipFill>
              <p:spPr>
                <a:xfrm>
                  <a:off x="3780000" y="6165720"/>
                  <a:ext cx="2376360" cy="200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8" name="" descr=""/>
                <p:cNvPicPr/>
                <p:nvPr/>
              </p:nvPicPr>
              <p:blipFill>
                <a:blip r:embed="rId3"/>
                <a:srcRect l="70570" t="73674" r="0" b="22953"/>
                <a:stretch/>
              </p:blipFill>
              <p:spPr>
                <a:xfrm>
                  <a:off x="1042920" y="6165720"/>
                  <a:ext cx="2376720" cy="2001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9" name="" descr=""/>
                <p:cNvPicPr/>
                <p:nvPr/>
              </p:nvPicPr>
              <p:blipFill>
                <a:blip r:embed="rId4"/>
                <a:srcRect l="70570" t="73674" r="0" b="22953"/>
                <a:stretch/>
              </p:blipFill>
              <p:spPr>
                <a:xfrm>
                  <a:off x="6516720" y="4653000"/>
                  <a:ext cx="2376360" cy="2001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50" name=""/>
              <p:cNvSpPr/>
              <p:nvPr/>
            </p:nvSpPr>
            <p:spPr>
              <a:xfrm rot="16200000">
                <a:off x="-401040" y="3001320"/>
                <a:ext cx="17269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75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fr-FR" sz="1200" spc="-1" strike="noStrike">
                    <a:solidFill>
                      <a:srgbClr val="000000"/>
                    </a:solidFill>
                    <a:latin typeface="Arial"/>
                  </a:rPr>
                  <a:t>Number of sequenc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1521000" y="3284640"/>
                <a:ext cx="1439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Bandicota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1592280" y="4797360"/>
                <a:ext cx="1297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Berylmy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1536840" y="297000"/>
                <a:ext cx="14065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Apodemu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1422360" y="1844640"/>
                <a:ext cx="1636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Arvicola terrestris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249800" y="297000"/>
                <a:ext cx="1511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Leopoldamy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4356000" y="1844640"/>
                <a:ext cx="1297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axomy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4284720" y="3284640"/>
                <a:ext cx="1439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icrotus arvalis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4500720" y="4797360"/>
                <a:ext cx="1008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u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7020000" y="297000"/>
                <a:ext cx="1655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</a:rPr>
                  <a:t>Myodes glareolus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= 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7182000" y="1844640"/>
                <a:ext cx="1333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Niviventer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7199280" y="3286080"/>
                <a:ext cx="1297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Rattus sp.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i="1" lang="fr-FR" sz="1000" spc="-1" strike="noStrike">
                    <a:solidFill>
                      <a:srgbClr val="000000"/>
                    </a:solidFill>
                    <a:latin typeface="Arial"/>
                  </a:rPr>
                  <a:t>m</a:t>
                </a:r>
                <a:r>
                  <a:rPr b="0" lang="fr-FR" sz="1000" spc="-1" strike="noStrike">
                    <a:solidFill>
                      <a:srgbClr val="000000"/>
                    </a:solidFill>
                    <a:latin typeface="Arial"/>
                  </a:rPr>
                  <a:t> = 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62" name="" descr=""/>
            <p:cNvPicPr/>
            <p:nvPr/>
          </p:nvPicPr>
          <p:blipFill>
            <a:blip r:embed="rId5"/>
            <a:srcRect l="38733" t="97399" r="33347" b="0"/>
            <a:stretch/>
          </p:blipFill>
          <p:spPr>
            <a:xfrm>
              <a:off x="3780000" y="6165720"/>
              <a:ext cx="2411280" cy="160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" descr=""/>
            <p:cNvPicPr/>
            <p:nvPr/>
          </p:nvPicPr>
          <p:blipFill>
            <a:blip r:embed="rId6"/>
            <a:srcRect l="69571" t="72769" r="1251" b="24899"/>
            <a:stretch/>
          </p:blipFill>
          <p:spPr>
            <a:xfrm>
              <a:off x="6440400" y="4678200"/>
              <a:ext cx="2602080" cy="1479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" descr=""/>
            <p:cNvPicPr/>
            <p:nvPr/>
          </p:nvPicPr>
          <p:blipFill>
            <a:blip r:embed="rId7"/>
            <a:srcRect l="7045" t="97375" r="65444" b="293"/>
            <a:stretch/>
          </p:blipFill>
          <p:spPr>
            <a:xfrm>
              <a:off x="1035000" y="6164280"/>
              <a:ext cx="2428920" cy="1476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"/>
          <p:cNvGrpSpPr/>
          <p:nvPr/>
        </p:nvGrpSpPr>
        <p:grpSpPr>
          <a:xfrm>
            <a:off x="250920" y="260280"/>
            <a:ext cx="8748720" cy="5616720"/>
            <a:chOff x="250920" y="260280"/>
            <a:chExt cx="8748720" cy="5616720"/>
          </a:xfrm>
        </p:grpSpPr>
        <p:grpSp>
          <p:nvGrpSpPr>
            <p:cNvPr id="66" name=""/>
            <p:cNvGrpSpPr/>
            <p:nvPr/>
          </p:nvGrpSpPr>
          <p:grpSpPr>
            <a:xfrm>
              <a:off x="717480" y="493920"/>
              <a:ext cx="8253000" cy="5330520"/>
              <a:chOff x="717480" y="493920"/>
              <a:chExt cx="8253000" cy="5330520"/>
            </a:xfrm>
          </p:grpSpPr>
          <p:grpSp>
            <p:nvGrpSpPr>
              <p:cNvPr id="67" name=""/>
              <p:cNvGrpSpPr/>
              <p:nvPr/>
            </p:nvGrpSpPr>
            <p:grpSpPr>
              <a:xfrm>
                <a:off x="717480" y="5292360"/>
                <a:ext cx="8251920" cy="106920"/>
                <a:chOff x="717480" y="5292360"/>
                <a:chExt cx="8251920" cy="106920"/>
              </a:xfrm>
            </p:grpSpPr>
            <p:sp>
              <p:nvSpPr>
                <p:cNvPr id="68" name=""/>
                <p:cNvSpPr/>
                <p:nvPr/>
              </p:nvSpPr>
              <p:spPr>
                <a:xfrm>
                  <a:off x="717480" y="5292360"/>
                  <a:ext cx="4878000" cy="10692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5650200" y="5292360"/>
                  <a:ext cx="3319200" cy="10692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0" name=""/>
              <p:cNvGrpSpPr/>
              <p:nvPr/>
            </p:nvGrpSpPr>
            <p:grpSpPr>
              <a:xfrm>
                <a:off x="717480" y="5177880"/>
                <a:ext cx="8252280" cy="114120"/>
                <a:chOff x="717480" y="5177880"/>
                <a:chExt cx="8252280" cy="114120"/>
              </a:xfrm>
            </p:grpSpPr>
            <p:sp>
              <p:nvSpPr>
                <p:cNvPr id="71" name=""/>
                <p:cNvSpPr/>
                <p:nvPr/>
              </p:nvSpPr>
              <p:spPr>
                <a:xfrm>
                  <a:off x="717480" y="5177880"/>
                  <a:ext cx="3008520" cy="1141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3714480" y="5177880"/>
                  <a:ext cx="56160" cy="11412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3766320" y="5177880"/>
                  <a:ext cx="5203440" cy="1141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4" name=""/>
              <p:cNvSpPr/>
              <p:nvPr/>
            </p:nvSpPr>
            <p:spPr>
              <a:xfrm>
                <a:off x="717480" y="5083560"/>
                <a:ext cx="4390560" cy="954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5" name=""/>
              <p:cNvGrpSpPr/>
              <p:nvPr/>
            </p:nvGrpSpPr>
            <p:grpSpPr>
              <a:xfrm>
                <a:off x="5108040" y="5083560"/>
                <a:ext cx="3861360" cy="95400"/>
                <a:chOff x="5108040" y="5083560"/>
                <a:chExt cx="3861360" cy="95400"/>
              </a:xfrm>
            </p:grpSpPr>
            <p:sp>
              <p:nvSpPr>
                <p:cNvPr id="76" name=""/>
                <p:cNvSpPr/>
                <p:nvPr/>
              </p:nvSpPr>
              <p:spPr>
                <a:xfrm>
                  <a:off x="5148000" y="5083560"/>
                  <a:ext cx="3821400" cy="954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5108040" y="5083560"/>
                  <a:ext cx="608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8" name=""/>
              <p:cNvGrpSpPr/>
              <p:nvPr/>
            </p:nvGrpSpPr>
            <p:grpSpPr>
              <a:xfrm>
                <a:off x="717480" y="4872600"/>
                <a:ext cx="8253000" cy="213840"/>
                <a:chOff x="717480" y="4872600"/>
                <a:chExt cx="8253000" cy="213840"/>
              </a:xfrm>
            </p:grpSpPr>
            <p:sp>
              <p:nvSpPr>
                <p:cNvPr id="79" name=""/>
                <p:cNvSpPr/>
                <p:nvPr/>
              </p:nvSpPr>
              <p:spPr>
                <a:xfrm>
                  <a:off x="717480" y="4872600"/>
                  <a:ext cx="6261120" cy="2138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7018560" y="4872600"/>
                  <a:ext cx="1951920" cy="2138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6978600" y="4872600"/>
                  <a:ext cx="70560" cy="2138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2" name=""/>
              <p:cNvGrpSpPr/>
              <p:nvPr/>
            </p:nvGrpSpPr>
            <p:grpSpPr>
              <a:xfrm>
                <a:off x="717480" y="4150440"/>
                <a:ext cx="8252280" cy="721440"/>
                <a:chOff x="717480" y="4150440"/>
                <a:chExt cx="8252280" cy="721440"/>
              </a:xfrm>
            </p:grpSpPr>
            <p:sp>
              <p:nvSpPr>
                <p:cNvPr id="83" name=""/>
                <p:cNvSpPr/>
                <p:nvPr/>
              </p:nvSpPr>
              <p:spPr>
                <a:xfrm>
                  <a:off x="717480" y="4150440"/>
                  <a:ext cx="1219680" cy="2138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1937160" y="4150440"/>
                  <a:ext cx="7032600" cy="2138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717480" y="4348800"/>
                  <a:ext cx="2357640" cy="33336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3075120" y="4348800"/>
                  <a:ext cx="5894280" cy="33336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3039480" y="4348800"/>
                  <a:ext cx="60840" cy="33336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4238640" y="4682160"/>
                  <a:ext cx="70920" cy="18972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717480" y="4677840"/>
                  <a:ext cx="3524760" cy="1940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4303080" y="4677840"/>
                  <a:ext cx="4666320" cy="1940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1" name=""/>
              <p:cNvGrpSpPr/>
              <p:nvPr/>
            </p:nvGrpSpPr>
            <p:grpSpPr>
              <a:xfrm>
                <a:off x="717480" y="493920"/>
                <a:ext cx="8252280" cy="3656520"/>
                <a:chOff x="717480" y="493920"/>
                <a:chExt cx="8252280" cy="3656520"/>
              </a:xfrm>
            </p:grpSpPr>
            <p:sp>
              <p:nvSpPr>
                <p:cNvPr id="92" name=""/>
                <p:cNvSpPr/>
                <p:nvPr/>
              </p:nvSpPr>
              <p:spPr>
                <a:xfrm>
                  <a:off x="717480" y="493920"/>
                  <a:ext cx="8252280" cy="1855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717480" y="2349720"/>
                  <a:ext cx="8252280" cy="137952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717480" y="3729600"/>
                  <a:ext cx="2439360" cy="9540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3156840" y="3729600"/>
                  <a:ext cx="5812560" cy="954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717480" y="3825000"/>
                  <a:ext cx="4919040" cy="2138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717480" y="4032000"/>
                  <a:ext cx="6545160" cy="118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5636520" y="3825000"/>
                  <a:ext cx="3332880" cy="2138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7262640" y="4032000"/>
                  <a:ext cx="1707120" cy="1184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00" name=""/>
              <p:cNvGrpSpPr/>
              <p:nvPr/>
            </p:nvGrpSpPr>
            <p:grpSpPr>
              <a:xfrm>
                <a:off x="717480" y="5396400"/>
                <a:ext cx="8252280" cy="428040"/>
                <a:chOff x="717480" y="5396400"/>
                <a:chExt cx="8252280" cy="428040"/>
              </a:xfrm>
            </p:grpSpPr>
            <p:sp>
              <p:nvSpPr>
                <p:cNvPr id="101" name=""/>
                <p:cNvSpPr/>
                <p:nvPr/>
              </p:nvSpPr>
              <p:spPr>
                <a:xfrm>
                  <a:off x="6937200" y="5491800"/>
                  <a:ext cx="2032560" cy="3326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717480" y="5491800"/>
                  <a:ext cx="5871960" cy="3326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102204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111960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188496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303516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337896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439452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689688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708660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8382960" y="5491800"/>
                  <a:ext cx="5904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1306440" y="5491800"/>
                  <a:ext cx="101160" cy="3326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7808400" y="5491800"/>
                  <a:ext cx="52560" cy="3326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1124280" y="5396400"/>
                  <a:ext cx="7845480" cy="954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880560" y="5396400"/>
                  <a:ext cx="2433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1265760" y="5396400"/>
                  <a:ext cx="914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1408320" y="5396400"/>
                  <a:ext cx="914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193716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2221920" y="5396400"/>
                  <a:ext cx="5112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242460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256644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3825360" y="5396400"/>
                  <a:ext cx="914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1641240" y="5396400"/>
                  <a:ext cx="81360" cy="9540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169884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2953440" y="5396400"/>
                  <a:ext cx="50760" cy="4280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3094200" y="5396400"/>
                  <a:ext cx="50760" cy="9540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478260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487584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5108040" y="5396400"/>
                  <a:ext cx="16272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559548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5686920" y="5396400"/>
                  <a:ext cx="50040" cy="4280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5829480" y="5396400"/>
                  <a:ext cx="50760" cy="9540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5930640" y="5396400"/>
                  <a:ext cx="46440" cy="42804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578448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588060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627408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675144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7180920" y="5396400"/>
                  <a:ext cx="5112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7371000" y="5396400"/>
                  <a:ext cx="5112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7709760" y="5396400"/>
                  <a:ext cx="6084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809856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8295840" y="5396400"/>
                  <a:ext cx="507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7808400" y="5396400"/>
                  <a:ext cx="7956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8847720" y="5396400"/>
                  <a:ext cx="12168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7953480" y="5396400"/>
                  <a:ext cx="50760" cy="95400"/>
                </a:xfrm>
                <a:prstGeom prst="rect">
                  <a:avLst/>
                </a:prstGeom>
                <a:solidFill>
                  <a:srgbClr val="3366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6416640" y="5396400"/>
                  <a:ext cx="914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1449720" y="5396400"/>
                  <a:ext cx="6084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1600920" y="5396400"/>
                  <a:ext cx="5184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4774680" y="5396400"/>
                  <a:ext cx="6084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7369200" y="5396400"/>
                  <a:ext cx="5616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7858440" y="5396400"/>
                  <a:ext cx="5436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8287560" y="5396400"/>
                  <a:ext cx="6084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6409440" y="5396400"/>
                  <a:ext cx="10548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1560600" y="5396400"/>
                  <a:ext cx="91440" cy="9540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8820000" y="5396400"/>
                  <a:ext cx="101160" cy="428040"/>
                </a:xfrm>
                <a:prstGeom prst="rect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ctr">
                  <a:sp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pic>
          <p:nvPicPr>
            <p:cNvPr id="156" name="" descr=""/>
            <p:cNvPicPr/>
            <p:nvPr/>
          </p:nvPicPr>
          <p:blipFill>
            <a:blip r:embed="rId1"/>
            <a:srcRect l="0" t="0" r="1758" b="1019"/>
            <a:stretch/>
          </p:blipFill>
          <p:spPr>
            <a:xfrm>
              <a:off x="250920" y="260280"/>
              <a:ext cx="8748720" cy="56167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57" name=""/>
          <p:cNvSpPr/>
          <p:nvPr/>
        </p:nvSpPr>
        <p:spPr>
          <a:xfrm>
            <a:off x="0" y="6308640"/>
            <a:ext cx="1403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Fig S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0T11:36:36Z</dcterms:created>
  <dc:creator>max</dc:creator>
  <dc:description/>
  <dc:language>en-US</dc:language>
  <cp:lastModifiedBy>max</cp:lastModifiedBy>
  <dcterms:modified xsi:type="dcterms:W3CDTF">2010-04-29T13:14:52Z</dcterms:modified>
  <cp:revision>27</cp:revision>
  <dc:subject/>
  <dc:title>Diapositive 1</dc:title>
</cp:coreProperties>
</file>